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10058400" cy="7772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448">
          <p15:clr>
            <a:srgbClr val="A4A3A4"/>
          </p15:clr>
        </p15:guide>
        <p15:guide id="2" pos="31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96" d="100"/>
          <a:sy n="96" d="100"/>
        </p:scale>
        <p:origin x="-594" y="-96"/>
      </p:cViewPr>
      <p:guideLst>
        <p:guide orient="horz" pos="2448"/>
        <p:guide pos="316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2414482"/>
            <a:ext cx="8549640" cy="166602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08760" y="4404360"/>
            <a:ext cx="7040880" cy="19862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99187" y="456989"/>
            <a:ext cx="1922621" cy="972629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7833" y="456989"/>
            <a:ext cx="5603716" cy="972629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4544" y="4994487"/>
            <a:ext cx="8549640" cy="154368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4544" y="3294275"/>
            <a:ext cx="8549640" cy="1700212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7837" y="2659169"/>
            <a:ext cx="3763169" cy="752411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58640" y="2659169"/>
            <a:ext cx="3763170" cy="752411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2920" y="311256"/>
            <a:ext cx="9052560" cy="1295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739795"/>
            <a:ext cx="4444207" cy="7250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2920" y="2464859"/>
            <a:ext cx="4444207" cy="44781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9534" y="1739795"/>
            <a:ext cx="4445953" cy="7250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9534" y="2464859"/>
            <a:ext cx="4445953" cy="44781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2920" y="309456"/>
            <a:ext cx="3309144" cy="131699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32554" y="309457"/>
            <a:ext cx="5622926" cy="663352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2920" y="1626447"/>
            <a:ext cx="3309144" cy="531653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71517" y="5440680"/>
            <a:ext cx="6035040" cy="64230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71517" y="694479"/>
            <a:ext cx="6035040" cy="46634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71517" y="6082983"/>
            <a:ext cx="6035040" cy="91217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311256"/>
            <a:ext cx="9052560" cy="1295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813565"/>
            <a:ext cx="9052560" cy="51294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7203865"/>
            <a:ext cx="234696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36620" y="7203865"/>
            <a:ext cx="318516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208520" y="7203865"/>
            <a:ext cx="234696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26" Type="http://schemas.openxmlformats.org/officeDocument/2006/relationships/image" Target="../media/image25.tiff"/><Relationship Id="rId3" Type="http://schemas.openxmlformats.org/officeDocument/2006/relationships/image" Target="../media/image2.tiff"/><Relationship Id="rId21" Type="http://schemas.openxmlformats.org/officeDocument/2006/relationships/image" Target="../media/image20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5" Type="http://schemas.openxmlformats.org/officeDocument/2006/relationships/image" Target="../media/image24.tiff"/><Relationship Id="rId33" Type="http://schemas.openxmlformats.org/officeDocument/2006/relationships/image" Target="../media/image32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29" Type="http://schemas.openxmlformats.org/officeDocument/2006/relationships/image" Target="../media/image28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24" Type="http://schemas.openxmlformats.org/officeDocument/2006/relationships/image" Target="../media/image23.tiff"/><Relationship Id="rId32" Type="http://schemas.openxmlformats.org/officeDocument/2006/relationships/image" Target="../media/image31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23" Type="http://schemas.openxmlformats.org/officeDocument/2006/relationships/image" Target="../media/image22.tiff"/><Relationship Id="rId28" Type="http://schemas.openxmlformats.org/officeDocument/2006/relationships/image" Target="../media/image27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31" Type="http://schemas.openxmlformats.org/officeDocument/2006/relationships/image" Target="../media/image30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21.tiff"/><Relationship Id="rId27" Type="http://schemas.openxmlformats.org/officeDocument/2006/relationships/image" Target="../media/image26.tiff"/><Relationship Id="rId30" Type="http://schemas.openxmlformats.org/officeDocument/2006/relationships/image" Target="../media/image2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519561" y="-76199"/>
            <a:ext cx="8795808" cy="6715355"/>
            <a:chOff x="-22776" y="-45720"/>
            <a:chExt cx="10177008" cy="7769861"/>
          </a:xfrm>
        </p:grpSpPr>
        <p:sp>
          <p:nvSpPr>
            <p:cNvPr id="62" name="TextBox 61"/>
            <p:cNvSpPr txBox="1"/>
            <p:nvPr/>
          </p:nvSpPr>
          <p:spPr>
            <a:xfrm rot="16200000">
              <a:off x="1721574" y="677799"/>
              <a:ext cx="1371600" cy="53416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rgbClr val="FF00FF"/>
                  </a:solidFill>
                  <a:latin typeface="Arial" pitchFamily="34" charset="0"/>
                  <a:cs typeface="Arial" pitchFamily="34" charset="0"/>
                </a:rPr>
                <a:t>TUNEL</a:t>
              </a:r>
              <a:r>
                <a:rPr lang="en-US" sz="1200" b="1" dirty="0" smtClean="0">
                  <a:solidFill>
                    <a:srgbClr val="3366FF"/>
                  </a:solidFill>
                  <a:latin typeface="Arial" pitchFamily="34" charset="0"/>
                  <a:cs typeface="Arial" pitchFamily="34" charset="0"/>
                </a:rPr>
                <a:t>DAPI</a:t>
              </a:r>
              <a:endParaRPr lang="en-US" sz="1200" b="1" dirty="0">
                <a:solidFill>
                  <a:srgbClr val="3366FF"/>
                </a:solidFill>
                <a:latin typeface="Arial" pitchFamily="34" charset="0"/>
                <a:cs typeface="Arial" pitchFamily="34" charset="0"/>
              </a:endParaRPr>
            </a:p>
            <a:p>
              <a:pPr algn="ctr"/>
              <a:endParaRPr lang="en-US" sz="1200" b="1" dirty="0" smtClean="0">
                <a:solidFill>
                  <a:srgbClr val="FF00FF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-790391" y="2306389"/>
              <a:ext cx="2146902" cy="6053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solidFill>
                    <a:srgbClr val="00FF00"/>
                  </a:solidFill>
                  <a:latin typeface="Arial" pitchFamily="34" charset="0"/>
                  <a:cs typeface="Arial" pitchFamily="34" charset="0"/>
                </a:rPr>
                <a:t>GFP</a:t>
              </a:r>
              <a:r>
                <a:rPr lang="en-US" sz="1400" b="1" dirty="0" smtClean="0">
                  <a:solidFill>
                    <a:srgbClr val="FF00FF"/>
                  </a:solidFill>
                  <a:latin typeface="Arial" pitchFamily="34" charset="0"/>
                  <a:cs typeface="Arial" pitchFamily="34" charset="0"/>
                </a:rPr>
                <a:t>TUNEL</a:t>
              </a:r>
              <a:r>
                <a:rPr lang="en-US" sz="1400" b="1" dirty="0" smtClean="0">
                  <a:solidFill>
                    <a:srgbClr val="3366FF"/>
                  </a:solidFill>
                  <a:latin typeface="Arial" pitchFamily="34" charset="0"/>
                  <a:cs typeface="Arial" pitchFamily="34" charset="0"/>
                </a:rPr>
                <a:t>DAPI</a:t>
              </a:r>
              <a:endParaRPr lang="en-US" sz="1400" b="1" dirty="0">
                <a:solidFill>
                  <a:srgbClr val="3366FF"/>
                </a:solidFill>
                <a:latin typeface="Arial" pitchFamily="34" charset="0"/>
                <a:cs typeface="Arial" pitchFamily="34" charset="0"/>
              </a:endParaRPr>
            </a:p>
            <a:p>
              <a:pPr algn="ctr"/>
              <a:endParaRPr lang="en-US" sz="1400" b="1" dirty="0" smtClean="0">
                <a:solidFill>
                  <a:srgbClr val="FF00FF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>
              <a:off x="689911" y="1600200"/>
              <a:ext cx="586976" cy="35610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-530522" y="3807206"/>
              <a:ext cx="1371600" cy="356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TUNEL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Rectangle 8"/>
            <p:cNvSpPr/>
            <p:nvPr/>
          </p:nvSpPr>
          <p:spPr>
            <a:xfrm>
              <a:off x="4795749" y="1600200"/>
              <a:ext cx="764276" cy="35610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T80A</a:t>
              </a:r>
            </a:p>
          </p:txBody>
        </p:sp>
        <p:sp>
          <p:nvSpPr>
            <p:cNvPr id="10" name="Rectangle 9"/>
            <p:cNvSpPr/>
            <p:nvPr/>
          </p:nvSpPr>
          <p:spPr>
            <a:xfrm>
              <a:off x="2002046" y="1600200"/>
              <a:ext cx="795111" cy="35610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K56R </a:t>
              </a: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384628" y="1600200"/>
              <a:ext cx="806673" cy="35610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K56Q</a:t>
              </a: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6170847" y="1600200"/>
              <a:ext cx="760522" cy="35610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T80E</a:t>
              </a: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572124" y="4672789"/>
              <a:ext cx="799475" cy="60538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T118A</a:t>
              </a: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7467599" y="1600200"/>
              <a:ext cx="914400" cy="35610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K115R </a:t>
              </a: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8925746" y="1600200"/>
              <a:ext cx="906785" cy="35610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K115Q</a:t>
              </a: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1899697" y="4672789"/>
              <a:ext cx="860634" cy="35610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T118E</a:t>
              </a: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6009361" y="4672789"/>
              <a:ext cx="922202" cy="35610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K122Q</a:t>
              </a: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3307094" y="4672789"/>
              <a:ext cx="779794" cy="35610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T118I</a:t>
              </a: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4668642" y="4672789"/>
              <a:ext cx="910639" cy="35610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K122R</a:t>
              </a:r>
            </a:p>
          </p:txBody>
        </p:sp>
        <p:sp>
          <p:nvSpPr>
            <p:cNvPr id="20" name="Rectangle 19"/>
            <p:cNvSpPr/>
            <p:nvPr/>
          </p:nvSpPr>
          <p:spPr>
            <a:xfrm>
              <a:off x="7130455" y="4672789"/>
              <a:ext cx="1599551" cy="35610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K115R/K122R</a:t>
              </a: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8531554" y="4672789"/>
              <a:ext cx="1622678" cy="35610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K115Q/K122Q</a:t>
              </a:r>
            </a:p>
          </p:txBody>
        </p:sp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04800" y="1899919"/>
              <a:ext cx="1371600" cy="1371600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04800" y="3299460"/>
              <a:ext cx="1371600" cy="1371600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694180" y="1899919"/>
              <a:ext cx="1371600" cy="1371600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694180" y="3299460"/>
              <a:ext cx="1371600" cy="1371600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 flipH="1">
              <a:off x="3083560" y="1899919"/>
              <a:ext cx="1371600" cy="1371600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 flipH="1">
              <a:off x="3083560" y="3299460"/>
              <a:ext cx="1371600" cy="1371600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 flipH="1">
              <a:off x="4472940" y="1899919"/>
              <a:ext cx="1371600" cy="1371600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 flipH="1">
              <a:off x="4472940" y="3299460"/>
              <a:ext cx="1371600" cy="1371600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5862320" y="1899919"/>
              <a:ext cx="1371600" cy="1371600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5862320" y="3299460"/>
              <a:ext cx="1371600" cy="1371600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7251700" y="1899919"/>
              <a:ext cx="1371600" cy="1371600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7251700" y="3299460"/>
              <a:ext cx="1371600" cy="1371600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8641080" y="1899919"/>
              <a:ext cx="1371600" cy="1371600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8641080" y="3299460"/>
              <a:ext cx="1371600" cy="1371600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04800" y="4953000"/>
              <a:ext cx="1371600" cy="1371600"/>
            </a:xfrm>
            <a:prstGeom prst="rect">
              <a:avLst/>
            </a:prstGeom>
          </p:spPr>
        </p:pic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04800" y="6352541"/>
              <a:ext cx="1371600" cy="1371600"/>
            </a:xfrm>
            <a:prstGeom prst="rect">
              <a:avLst/>
            </a:prstGeom>
          </p:spPr>
        </p:pic>
        <p:pic>
          <p:nvPicPr>
            <p:cNvPr id="40" name="Picture 39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694180" y="4953000"/>
              <a:ext cx="1371600" cy="1371600"/>
            </a:xfrm>
            <a:prstGeom prst="rect">
              <a:avLst/>
            </a:prstGeom>
          </p:spPr>
        </p:pic>
        <p:pic>
          <p:nvPicPr>
            <p:cNvPr id="41" name="Picture 40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694180" y="6352541"/>
              <a:ext cx="1371600" cy="1371600"/>
            </a:xfrm>
            <a:prstGeom prst="rect">
              <a:avLst/>
            </a:prstGeom>
          </p:spPr>
        </p:pic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083560" y="4953000"/>
              <a:ext cx="1371600" cy="1371600"/>
            </a:xfrm>
            <a:prstGeom prst="rect">
              <a:avLst/>
            </a:prstGeom>
          </p:spPr>
        </p:pic>
        <p:pic>
          <p:nvPicPr>
            <p:cNvPr id="43" name="Picture 42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083560" y="6352541"/>
              <a:ext cx="1371600" cy="1371600"/>
            </a:xfrm>
            <a:prstGeom prst="rect">
              <a:avLst/>
            </a:prstGeom>
          </p:spPr>
        </p:pic>
        <p:pic>
          <p:nvPicPr>
            <p:cNvPr id="44" name="Picture 43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472940" y="4953000"/>
              <a:ext cx="1371600" cy="1371600"/>
            </a:xfrm>
            <a:prstGeom prst="rect">
              <a:avLst/>
            </a:prstGeom>
          </p:spPr>
        </p:pic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472940" y="6352541"/>
              <a:ext cx="1371600" cy="1371600"/>
            </a:xfrm>
            <a:prstGeom prst="rect">
              <a:avLst/>
            </a:prstGeom>
          </p:spPr>
        </p:pic>
        <p:pic>
          <p:nvPicPr>
            <p:cNvPr id="46" name="Picture 45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5862320" y="4953000"/>
              <a:ext cx="1371600" cy="1371600"/>
            </a:xfrm>
            <a:prstGeom prst="rect">
              <a:avLst/>
            </a:prstGeom>
          </p:spPr>
        </p:pic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5862320" y="6352541"/>
              <a:ext cx="1371600" cy="1371600"/>
            </a:xfrm>
            <a:prstGeom prst="rect">
              <a:avLst/>
            </a:prstGeom>
          </p:spPr>
        </p:pic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7251700" y="4953000"/>
              <a:ext cx="1371600" cy="1371600"/>
            </a:xfrm>
            <a:prstGeom prst="rect">
              <a:avLst/>
            </a:prstGeom>
          </p:spPr>
        </p:pic>
        <p:pic>
          <p:nvPicPr>
            <p:cNvPr id="49" name="Picture 48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7251700" y="6352541"/>
              <a:ext cx="1371600" cy="1371600"/>
            </a:xfrm>
            <a:prstGeom prst="rect">
              <a:avLst/>
            </a:prstGeom>
          </p:spPr>
        </p:pic>
        <p:pic>
          <p:nvPicPr>
            <p:cNvPr id="50" name="Picture 49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8641080" y="4953000"/>
              <a:ext cx="1371600" cy="1371600"/>
            </a:xfrm>
            <a:prstGeom prst="rect">
              <a:avLst/>
            </a:prstGeom>
          </p:spPr>
        </p:pic>
        <p:pic>
          <p:nvPicPr>
            <p:cNvPr id="51" name="Picture 50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8641080" y="6352541"/>
              <a:ext cx="1371600" cy="1371600"/>
            </a:xfrm>
            <a:prstGeom prst="rect">
              <a:avLst/>
            </a:prstGeom>
          </p:spPr>
        </p:pic>
        <p:pic>
          <p:nvPicPr>
            <p:cNvPr id="52" name="Picture 51"/>
            <p:cNvPicPr>
              <a:picLocks noChangeAspect="1"/>
            </p:cNvPicPr>
            <p:nvPr/>
          </p:nvPicPr>
          <p:blipFill>
            <a:blip r:embed="rId30" cstate="print">
              <a:lum contrast="-30000"/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2431594" y="259080"/>
              <a:ext cx="1371600" cy="1371600"/>
            </a:xfrm>
            <a:prstGeom prst="rect">
              <a:avLst/>
            </a:prstGeom>
          </p:spPr>
        </p:pic>
        <p:pic>
          <p:nvPicPr>
            <p:cNvPr id="53" name="Picture 52"/>
            <p:cNvPicPr>
              <a:picLocks noChangeAspect="1"/>
            </p:cNvPicPr>
            <p:nvPr/>
          </p:nvPicPr>
          <p:blipFill>
            <a:blip r:embed="rId31" cstate="print">
              <a:lum contrast="-30000"/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820974" y="259080"/>
              <a:ext cx="1371600" cy="1371600"/>
            </a:xfrm>
            <a:prstGeom prst="rect">
              <a:avLst/>
            </a:prstGeom>
          </p:spPr>
        </p:pic>
        <p:sp>
          <p:nvSpPr>
            <p:cNvPr id="54" name="Rectangle 53"/>
            <p:cNvSpPr/>
            <p:nvPr/>
          </p:nvSpPr>
          <p:spPr>
            <a:xfrm>
              <a:off x="2562545" y="-33754"/>
              <a:ext cx="1129322" cy="35610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GMR-hid</a:t>
              </a:r>
            </a:p>
          </p:txBody>
        </p:sp>
        <p:pic>
          <p:nvPicPr>
            <p:cNvPr id="56" name="Picture 55"/>
            <p:cNvPicPr>
              <a:picLocks noChangeAspect="1"/>
            </p:cNvPicPr>
            <p:nvPr/>
          </p:nvPicPr>
          <p:blipFill>
            <a:blip r:embed="rId3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5210354" y="259080"/>
              <a:ext cx="1371600" cy="1371600"/>
            </a:xfrm>
            <a:prstGeom prst="rect">
              <a:avLst/>
            </a:prstGeom>
          </p:spPr>
        </p:pic>
        <p:pic>
          <p:nvPicPr>
            <p:cNvPr id="57" name="Picture 56"/>
            <p:cNvPicPr>
              <a:picLocks noChangeAspect="1"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6599734" y="259080"/>
              <a:ext cx="1371600" cy="1371600"/>
            </a:xfrm>
            <a:prstGeom prst="rect">
              <a:avLst/>
            </a:prstGeom>
          </p:spPr>
        </p:pic>
        <p:sp>
          <p:nvSpPr>
            <p:cNvPr id="58" name="Rectangle 57"/>
            <p:cNvSpPr/>
            <p:nvPr/>
          </p:nvSpPr>
          <p:spPr>
            <a:xfrm>
              <a:off x="5625425" y="-45720"/>
              <a:ext cx="541129" cy="35610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err="1" smtClean="0">
                  <a:latin typeface="Arial" pitchFamily="34" charset="0"/>
                  <a:cs typeface="Arial" pitchFamily="34" charset="0"/>
                </a:rPr>
                <a:t>yw</a:t>
              </a:r>
              <a:endParaRPr lang="en-US" sz="1400" b="1" i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278388" y="1871246"/>
              <a:ext cx="385110" cy="3917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C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668110" y="1871246"/>
              <a:ext cx="385110" cy="3917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D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058759" y="1871246"/>
              <a:ext cx="372010" cy="3917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E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4407498" y="1871246"/>
              <a:ext cx="358680" cy="3917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F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5791201" y="1871246"/>
              <a:ext cx="398325" cy="3917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G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7234100" y="1871246"/>
              <a:ext cx="385110" cy="3917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H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8616154" y="1871246"/>
              <a:ext cx="279623" cy="3917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I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276225" y="4953000"/>
              <a:ext cx="345697" cy="3917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J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1665945" y="4953000"/>
              <a:ext cx="391717" cy="3917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K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3056594" y="4953000"/>
              <a:ext cx="354391" cy="3917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L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4405335" y="4953000"/>
              <a:ext cx="411423" cy="3917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M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5789037" y="4953000"/>
              <a:ext cx="385110" cy="3917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N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7231936" y="4953000"/>
              <a:ext cx="398325" cy="3917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O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8613992" y="4953000"/>
              <a:ext cx="367721" cy="3917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P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2434135" y="228600"/>
              <a:ext cx="376879" cy="3917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A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5149992" y="228600"/>
              <a:ext cx="385110" cy="3917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B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7" name="Straight Arrow Connector 76"/>
            <p:cNvCxnSpPr/>
            <p:nvPr/>
          </p:nvCxnSpPr>
          <p:spPr>
            <a:xfrm>
              <a:off x="4453434" y="533400"/>
              <a:ext cx="304800" cy="15240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/>
            <p:cNvSpPr txBox="1"/>
            <p:nvPr/>
          </p:nvSpPr>
          <p:spPr>
            <a:xfrm rot="16200000">
              <a:off x="-736973" y="5380682"/>
              <a:ext cx="2048599" cy="6053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solidFill>
                    <a:srgbClr val="00FF00"/>
                  </a:solidFill>
                  <a:latin typeface="Arial" pitchFamily="34" charset="0"/>
                  <a:cs typeface="Arial" pitchFamily="34" charset="0"/>
                </a:rPr>
                <a:t>GFP</a:t>
              </a:r>
              <a:r>
                <a:rPr lang="en-US" sz="1400" b="1" dirty="0" smtClean="0">
                  <a:solidFill>
                    <a:srgbClr val="FF00FF"/>
                  </a:solidFill>
                  <a:latin typeface="Arial" pitchFamily="34" charset="0"/>
                  <a:cs typeface="Arial" pitchFamily="34" charset="0"/>
                </a:rPr>
                <a:t>TUNEL</a:t>
              </a:r>
              <a:r>
                <a:rPr lang="en-US" sz="1400" b="1" dirty="0" smtClean="0">
                  <a:solidFill>
                    <a:srgbClr val="3366FF"/>
                  </a:solidFill>
                  <a:latin typeface="Arial" pitchFamily="34" charset="0"/>
                  <a:cs typeface="Arial" pitchFamily="34" charset="0"/>
                </a:rPr>
                <a:t>DAPI</a:t>
              </a:r>
              <a:endParaRPr lang="en-US" sz="1400" b="1" dirty="0">
                <a:solidFill>
                  <a:srgbClr val="3366FF"/>
                </a:solidFill>
                <a:latin typeface="Arial" pitchFamily="34" charset="0"/>
                <a:cs typeface="Arial" pitchFamily="34" charset="0"/>
              </a:endParaRPr>
            </a:p>
            <a:p>
              <a:pPr algn="ctr"/>
              <a:endParaRPr lang="en-US" sz="1400" b="1" dirty="0" smtClean="0">
                <a:solidFill>
                  <a:srgbClr val="FF00FF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 rot="16200000">
              <a:off x="-526257" y="6832346"/>
              <a:ext cx="1371600" cy="356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TUNEL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" name="Rectangle 2"/>
          <p:cNvSpPr/>
          <p:nvPr/>
        </p:nvSpPr>
        <p:spPr>
          <a:xfrm>
            <a:off x="12701" y="76200"/>
            <a:ext cx="171199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upplemental Figure </a:t>
            </a:r>
            <a:r>
              <a:rPr lang="en-US" sz="1000" b="1" dirty="0" smtClean="0">
                <a:latin typeface="Arial"/>
                <a:cs typeface="Arial"/>
              </a:rPr>
              <a:t>3</a:t>
            </a:r>
            <a:endParaRPr lang="en-US" sz="1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6376715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</TotalTime>
  <Words>40</Words>
  <Application>Microsoft Office PowerPoint</Application>
  <PresentationFormat>Custom</PresentationFormat>
  <Paragraphs>3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illary Graves</dc:creator>
  <cp:lastModifiedBy>0002401</cp:lastModifiedBy>
  <cp:revision>28</cp:revision>
  <cp:lastPrinted>2015-11-20T14:49:24Z</cp:lastPrinted>
  <dcterms:created xsi:type="dcterms:W3CDTF">2015-10-29T21:52:50Z</dcterms:created>
  <dcterms:modified xsi:type="dcterms:W3CDTF">2016-02-22T11:47:55Z</dcterms:modified>
</cp:coreProperties>
</file>